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28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5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45E523-D296-4162-8337-3A355728DC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2325F5-2AE6-474B-A025-8150C430AF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A2F88C-0CFB-4AD3-8F6A-4D5D44C24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526619-9D3B-4DB6-A315-8B3D7B78F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A1831B-E7E3-4D8C-8E12-73E49E6B71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881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C079D5-469F-4C7B-96D4-4E3D0A557F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3752AB-09E6-4458-B377-E921ED2A15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A25508-2648-4AD4-A92F-D30274E2E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726F70-84BB-4B2F-8890-B59FBB36D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4065CB-00E5-464E-859F-475DFA7D7B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594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31E42C-0E32-47E9-BF39-379B04EFDB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65D7E6-AE70-4B5C-AB88-21C3D0F0CF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32B872-45D3-4B63-8C3B-B5EA1130F8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8FF447-564E-43F8-BD65-171411AE1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38CCE0-F8FC-42E1-ACD5-B67056AD8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480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278A44-1666-4B78-844F-67366D8966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CD088E-26D4-435D-BEFA-73AB104DCE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EC5FFC-562E-4D8B-9CE9-8C4ECC1E4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474CA3-532A-43F8-BF6C-CC0B2EB47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345EE4-6EA4-416B-80C1-E0C3951907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655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4056E7-4337-4DAE-8924-4463089AFC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E5D932-77C8-42E3-AABF-89BE2514F9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53C914-97C6-4F80-9DAD-C41AFA352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1396B1-279B-4591-AA6C-DBE0C2ACD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B8794F-D029-49B1-82D8-A0796EB84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30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BCFE32-4F37-4EC7-BE9F-DE6078486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72786D-265D-4B81-AC32-3AA49EDDC5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3B3921-DFD3-4473-A12A-17735A7DB5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AE2D08-2384-4A8B-9F79-5DF2DB837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82191D-89C5-458D-AD91-B983E8AC0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45FE80-D863-4655-BAA5-7A96BF95F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731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3FF8D8-4503-4994-A67F-CB61DF07B5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BC006B-7FA9-475F-8D98-D3FBF16156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53AD71-7CC2-43BF-B70A-C8C6620C19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3A98AD-1544-46CE-9BB6-FC35E0A496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5936ABF-F8C0-4421-9EBA-2355814B2A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2FCD6C-EB94-4A66-9A07-0787FD931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C90554-2702-429F-B4C4-06F5DC6BD9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EF4CE8-D52E-4B2D-8E8D-F39D0066E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3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A36330-F5C1-45DC-8329-FBB848ABA4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34B1FF3-CA14-4D15-8524-5EBF5A5BB6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7FE3EFB-A08B-4BE2-AE60-BC7764339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2B9598-057C-4609-BF5F-FA47E16BE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115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0AFE683-CB15-429A-ACC6-9906A20BA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64EC454-9334-4D78-88EA-7880961E79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B763DF8-2BE2-4A94-849B-1DB2352C9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086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F3345C-AB4A-451D-B730-11EA90EDB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82E787-AADE-4EC6-BD4A-0080239EE4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4BBBAD-EB34-4695-94A9-D2A8DC38FC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2BADF1-DF92-4CD5-A3FA-B35FCBDEA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C19F6F-AB0D-4E61-9697-CB489C818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851AC8-2FE5-4F20-82F7-4125884B2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021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654524-0439-4469-9D0E-DC16D8D839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6FBAB3C-84D1-4BA5-959E-F7552F4895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CF6C32-B03A-49CA-852D-FA854A6133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BB53FB-DE4E-4914-B1A3-52B7F1834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10CF8F-832E-41C8-9A2F-B35BA7CAF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D70367-6DE6-4492-94DA-DDF147E57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384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528F9C2-AA47-4FC8-B771-2FBE9C09B3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19BB73-71CF-4897-8E70-C915A6DA78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117DE3-A0CD-4C48-B8E6-3F5DB41FA4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6434B-A19C-4D8F-893F-881F27A246F4}" type="datetimeFigureOut">
              <a:rPr lang="en-US" smtClean="0"/>
              <a:t>6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E96920-1843-40F1-9D65-D7F6F6C90F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32C6D0-1438-42BA-AAD0-BB403DEBC7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9F12FB-F932-450D-B858-D28946FC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562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D511E64-9F5C-DE05-2533-FEC6A75DE59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8662"/>
          <a:stretch/>
        </p:blipFill>
        <p:spPr>
          <a:xfrm>
            <a:off x="1135380" y="941882"/>
            <a:ext cx="9399758" cy="277286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940BE86-203F-0E98-68D8-83A2BB05781B}"/>
              </a:ext>
            </a:extLst>
          </p:cNvPr>
          <p:cNvSpPr txBox="1"/>
          <p:nvPr/>
        </p:nvSpPr>
        <p:spPr>
          <a:xfrm>
            <a:off x="740196" y="3831959"/>
            <a:ext cx="10428902" cy="9292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15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. </a:t>
            </a:r>
            <a:r>
              <a:rPr lang="en-US" sz="1200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hanges in renal functional parameters, serum </a:t>
            </a:r>
            <a:r>
              <a:rPr lang="en-US" sz="1200" b="1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BUN, </a:t>
            </a:r>
            <a:r>
              <a:rPr lang="en-US" sz="1200" b="1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reatinine and </a:t>
            </a:r>
            <a:r>
              <a:rPr lang="en-US" sz="1200" b="1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c)</a:t>
            </a:r>
            <a:r>
              <a:rPr lang="en-US" sz="1200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hosphorous following intra-peritoneal (IP) injection of 20mg/kg cisplatin over 7 days in C57BL/6 male and female mice. </a:t>
            </a:r>
            <a:r>
              <a:rPr lang="en-US" sz="1200" b="1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tatistical analysis</a:t>
            </a:r>
            <a:r>
              <a:rPr lang="en-US" sz="1200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: (</a:t>
            </a:r>
            <a:r>
              <a:rPr lang="en-US" sz="1200" b="1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-c</a:t>
            </a:r>
            <a:r>
              <a:rPr lang="en-US" sz="1200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Results expressed as mean ± SD (n=4 biological replicates). Statistical significance was determined by mixed ANOVA followed by </a:t>
            </a:r>
            <a:r>
              <a:rPr lang="en-US" sz="1200" kern="12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idak’s</a:t>
            </a:r>
            <a:r>
              <a:rPr lang="en-US" sz="1200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ost hoc correction for evaluating multiple pairwise comparison.  Data were considered significant only if </a:t>
            </a:r>
            <a:r>
              <a:rPr lang="en-US" sz="1200" i="1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  <a:sym typeface="Symbol" pitchFamily="2" charset="2"/>
              </a:rPr>
              <a:t></a:t>
            </a:r>
            <a:r>
              <a:rPr lang="en-US" sz="1200" kern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0.05. </a:t>
            </a:r>
            <a:endParaRPr lang="en-US" sz="12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78808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7D515F5-724E-3298-B10F-8990B9D4767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3540"/>
          <a:stretch/>
        </p:blipFill>
        <p:spPr>
          <a:xfrm>
            <a:off x="2987040" y="225617"/>
            <a:ext cx="5482590" cy="449497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ADFD4B1-14D3-E378-A7EC-70F811D8C751}"/>
              </a:ext>
            </a:extLst>
          </p:cNvPr>
          <p:cNvSpPr txBox="1"/>
          <p:nvPr/>
        </p:nvSpPr>
        <p:spPr>
          <a:xfrm>
            <a:off x="2987040" y="5157988"/>
            <a:ext cx="58940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2: PCA plot at Day 0 , Day 2, Day 3 and Day5 following cisplatin injection for (a) male and (b) female C57BL/6 mice. (b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arplo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howing GO pathways UP/ DOWN regulated between male and female mice at (c) Day 2 and (d) Day 3 following cisplatin injection. </a:t>
            </a:r>
          </a:p>
        </p:txBody>
      </p:sp>
    </p:spTree>
    <p:extLst>
      <p:ext uri="{BB962C8B-B14F-4D97-AF65-F5344CB8AC3E}">
        <p14:creationId xmlns:p14="http://schemas.microsoft.com/office/powerpoint/2010/main" val="32943596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A5B0C358-7400-5142-1C1E-3C811B5C6F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1915691"/>
              </p:ext>
            </p:extLst>
          </p:nvPr>
        </p:nvGraphicFramePr>
        <p:xfrm>
          <a:off x="707602" y="670279"/>
          <a:ext cx="7940837" cy="1679647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871302">
                  <a:extLst>
                    <a:ext uri="{9D8B030D-6E8A-4147-A177-3AD203B41FA5}">
                      <a16:colId xmlns:a16="http://schemas.microsoft.com/office/drawing/2014/main" val="2295369836"/>
                    </a:ext>
                  </a:extLst>
                </a:gridCol>
                <a:gridCol w="1003608">
                  <a:extLst>
                    <a:ext uri="{9D8B030D-6E8A-4147-A177-3AD203B41FA5}">
                      <a16:colId xmlns:a16="http://schemas.microsoft.com/office/drawing/2014/main" val="3941270236"/>
                    </a:ext>
                  </a:extLst>
                </a:gridCol>
                <a:gridCol w="911765">
                  <a:extLst>
                    <a:ext uri="{9D8B030D-6E8A-4147-A177-3AD203B41FA5}">
                      <a16:colId xmlns:a16="http://schemas.microsoft.com/office/drawing/2014/main" val="2945700102"/>
                    </a:ext>
                  </a:extLst>
                </a:gridCol>
                <a:gridCol w="746980">
                  <a:extLst>
                    <a:ext uri="{9D8B030D-6E8A-4147-A177-3AD203B41FA5}">
                      <a16:colId xmlns:a16="http://schemas.microsoft.com/office/drawing/2014/main" val="4182542121"/>
                    </a:ext>
                  </a:extLst>
                </a:gridCol>
                <a:gridCol w="853691">
                  <a:extLst>
                    <a:ext uri="{9D8B030D-6E8A-4147-A177-3AD203B41FA5}">
                      <a16:colId xmlns:a16="http://schemas.microsoft.com/office/drawing/2014/main" val="2246495213"/>
                    </a:ext>
                  </a:extLst>
                </a:gridCol>
                <a:gridCol w="778994">
                  <a:extLst>
                    <a:ext uri="{9D8B030D-6E8A-4147-A177-3AD203B41FA5}">
                      <a16:colId xmlns:a16="http://schemas.microsoft.com/office/drawing/2014/main" val="765854765"/>
                    </a:ext>
                  </a:extLst>
                </a:gridCol>
                <a:gridCol w="789665">
                  <a:extLst>
                    <a:ext uri="{9D8B030D-6E8A-4147-A177-3AD203B41FA5}">
                      <a16:colId xmlns:a16="http://schemas.microsoft.com/office/drawing/2014/main" val="4081788309"/>
                    </a:ext>
                  </a:extLst>
                </a:gridCol>
                <a:gridCol w="992416">
                  <a:extLst>
                    <a:ext uri="{9D8B030D-6E8A-4147-A177-3AD203B41FA5}">
                      <a16:colId xmlns:a16="http://schemas.microsoft.com/office/drawing/2014/main" val="1069056380"/>
                    </a:ext>
                  </a:extLst>
                </a:gridCol>
                <a:gridCol w="992416">
                  <a:extLst>
                    <a:ext uri="{9D8B030D-6E8A-4147-A177-3AD203B41FA5}">
                      <a16:colId xmlns:a16="http://schemas.microsoft.com/office/drawing/2014/main" val="1311169275"/>
                    </a:ext>
                  </a:extLst>
                </a:gridCol>
              </a:tblGrid>
              <a:tr h="480767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atin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cn2 (NGA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vcr1</a:t>
                      </a:r>
                    </a:p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KIM-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ase-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ular </a:t>
                      </a:r>
                    </a:p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t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44385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-MS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17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139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47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30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2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79 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62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9 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42933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-MS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45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38 %</a:t>
                      </a:r>
                    </a:p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60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15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73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29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72 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33956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-MS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60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50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47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89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8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3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59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71 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1815972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35FE05D7-703F-13A9-E4B4-A9F1F93E3DEA}"/>
              </a:ext>
            </a:extLst>
          </p:cNvPr>
          <p:cNvSpPr txBox="1"/>
          <p:nvPr/>
        </p:nvSpPr>
        <p:spPr>
          <a:xfrm>
            <a:off x="642288" y="2349926"/>
            <a:ext cx="8083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anges in Renal Functional and Inflammatory Parameters by different MSC sources following cisplatin-induced AKI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0345C50-ED8E-576B-F5FA-FDB26C9DEC19}"/>
              </a:ext>
            </a:extLst>
          </p:cNvPr>
          <p:cNvSpPr txBox="1"/>
          <p:nvPr/>
        </p:nvSpPr>
        <p:spPr>
          <a:xfrm>
            <a:off x="719797" y="276203"/>
            <a:ext cx="7728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S1 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2D94DAA-D966-1F82-6375-939C3360E3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8577205"/>
              </p:ext>
            </p:extLst>
          </p:nvPr>
        </p:nvGraphicFramePr>
        <p:xfrm>
          <a:off x="844223" y="3495878"/>
          <a:ext cx="7288270" cy="3154731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3644135">
                  <a:extLst>
                    <a:ext uri="{9D8B030D-6E8A-4147-A177-3AD203B41FA5}">
                      <a16:colId xmlns:a16="http://schemas.microsoft.com/office/drawing/2014/main" val="3769326481"/>
                    </a:ext>
                  </a:extLst>
                </a:gridCol>
                <a:gridCol w="3644135">
                  <a:extLst>
                    <a:ext uri="{9D8B030D-6E8A-4147-A177-3AD203B41FA5}">
                      <a16:colId xmlns:a16="http://schemas.microsoft.com/office/drawing/2014/main" val="42564803"/>
                    </a:ext>
                  </a:extLst>
                </a:gridCol>
              </a:tblGrid>
              <a:tr h="442353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_name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’-3’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76392138"/>
                  </a:ext>
                </a:extLst>
              </a:tr>
              <a:tr h="2331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ase_fw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CAGAGAGACATTCATGG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79060571"/>
                  </a:ext>
                </a:extLst>
              </a:tr>
              <a:tr h="3110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ase_re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GTAGTCGCCTCTGAAG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26852386"/>
                  </a:ext>
                </a:extLst>
              </a:tr>
              <a:tr h="3110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M1_fw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CAGGAAGACCCACGACTATTTC 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09037739"/>
                  </a:ext>
                </a:extLst>
              </a:tr>
              <a:tr h="2168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M1_rev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GTGTGTAGATGTTGGAGGAGTG 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84198921"/>
                  </a:ext>
                </a:extLst>
              </a:tr>
              <a:tr h="20738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AL_fw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TGAATGGGTGGTGAGTG 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18266032"/>
                  </a:ext>
                </a:extLst>
              </a:tr>
              <a:tr h="2450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AL_re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CTGGCAACAGGAAAGATG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78053037"/>
                  </a:ext>
                </a:extLst>
              </a:tr>
              <a:tr h="22624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Symbol" pitchFamily="2" charset="2"/>
                        </a:rPr>
                        <a:t></a:t>
                      </a: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Symbol" pitchFamily="2" charset="2"/>
                        </a:rPr>
                        <a:t>_</a:t>
                      </a:r>
                      <a:r>
                        <a:rPr lang="en-US" sz="11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Symbol" pitchFamily="2" charset="2"/>
                        </a:rPr>
                        <a:t>fwd</a:t>
                      </a:r>
                      <a:endParaRPr lang="en-US" sz="11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GCCCACGTCGTAGCAAACC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27043763"/>
                  </a:ext>
                </a:extLst>
              </a:tr>
              <a:tr h="216817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n-US" sz="1100" b="0" kern="1200" dirty="0" err="1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Symbol" pitchFamily="2" charset="2"/>
                        </a:rPr>
                        <a:t></a:t>
                      </a:r>
                      <a:r>
                        <a:rPr lang="en-US" sz="11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Symbol" pitchFamily="2" charset="2"/>
                        </a:rPr>
                        <a:t>_rev</a:t>
                      </a:r>
                      <a:endParaRPr lang="en-US" sz="11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GAGGAGCACGTAGTCGG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29550343"/>
                  </a:ext>
                </a:extLst>
              </a:tr>
              <a:tr h="19796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_fw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66666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AGAGCTTGAAGGTGTTGCC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1786114"/>
                  </a:ext>
                </a:extLst>
              </a:tr>
              <a:tr h="16968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_rev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66666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CAAGGGAGCTTCAGGGTC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6923535"/>
                  </a:ext>
                </a:extLst>
              </a:tr>
              <a:tr h="162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_fw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ACTGCCACCCAGAAGACTG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66422796"/>
                  </a:ext>
                </a:extLst>
              </a:tr>
              <a:tr h="1829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_rev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CCAGTGAGCTTCCCGTTCAG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336422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7EBADA0-77C5-EC60-CBFB-172FBD09FF68}"/>
              </a:ext>
            </a:extLst>
          </p:cNvPr>
          <p:cNvSpPr txBox="1"/>
          <p:nvPr/>
        </p:nvSpPr>
        <p:spPr>
          <a:xfrm>
            <a:off x="844223" y="3126546"/>
            <a:ext cx="7728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S2 </a:t>
            </a:r>
          </a:p>
        </p:txBody>
      </p:sp>
    </p:spTree>
    <p:extLst>
      <p:ext uri="{BB962C8B-B14F-4D97-AF65-F5344CB8AC3E}">
        <p14:creationId xmlns:p14="http://schemas.microsoft.com/office/powerpoint/2010/main" val="3716523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87</TotalTime>
  <Words>307</Words>
  <Application>Microsoft Macintosh PowerPoint</Application>
  <PresentationFormat>Widescreen</PresentationFormat>
  <Paragraphs>6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antika Ganguly</dc:creator>
  <cp:lastModifiedBy>Abantika Ganguly</cp:lastModifiedBy>
  <cp:revision>35</cp:revision>
  <dcterms:created xsi:type="dcterms:W3CDTF">2024-03-12T21:25:21Z</dcterms:created>
  <dcterms:modified xsi:type="dcterms:W3CDTF">2024-06-21T16:02:43Z</dcterms:modified>
</cp:coreProperties>
</file>